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3" d="100"/>
          <a:sy n="83" d="100"/>
        </p:scale>
        <p:origin x="68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5E106-B76B-4577-B4FA-59070E5BCED8}" type="datetimeFigureOut">
              <a:rPr lang="en-US" smtClean="0"/>
              <a:t>2023-06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0636-1D4A-4A18-B92A-28DA03F8E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887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5E106-B76B-4577-B4FA-59070E5BCED8}" type="datetimeFigureOut">
              <a:rPr lang="en-US" smtClean="0"/>
              <a:t>2023-06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0636-1D4A-4A18-B92A-28DA03F8E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21875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5E106-B76B-4577-B4FA-59070E5BCED8}" type="datetimeFigureOut">
              <a:rPr lang="en-US" smtClean="0"/>
              <a:t>2023-06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0636-1D4A-4A18-B92A-28DA03F8E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14248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5E106-B76B-4577-B4FA-59070E5BCED8}" type="datetimeFigureOut">
              <a:rPr lang="en-US" smtClean="0"/>
              <a:t>2023-06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0636-1D4A-4A18-B92A-28DA03F8E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4262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5E106-B76B-4577-B4FA-59070E5BCED8}" type="datetimeFigureOut">
              <a:rPr lang="en-US" smtClean="0"/>
              <a:t>2023-06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0636-1D4A-4A18-B92A-28DA03F8E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7225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5E106-B76B-4577-B4FA-59070E5BCED8}" type="datetimeFigureOut">
              <a:rPr lang="en-US" smtClean="0"/>
              <a:t>2023-06-0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0636-1D4A-4A18-B92A-28DA03F8E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76585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5E106-B76B-4577-B4FA-59070E5BCED8}" type="datetimeFigureOut">
              <a:rPr lang="en-US" smtClean="0"/>
              <a:t>2023-06-0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0636-1D4A-4A18-B92A-28DA03F8E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9249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5E106-B76B-4577-B4FA-59070E5BCED8}" type="datetimeFigureOut">
              <a:rPr lang="en-US" smtClean="0"/>
              <a:t>2023-06-0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0636-1D4A-4A18-B92A-28DA03F8E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54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5E106-B76B-4577-B4FA-59070E5BCED8}" type="datetimeFigureOut">
              <a:rPr lang="en-US" smtClean="0"/>
              <a:t>2023-06-0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0636-1D4A-4A18-B92A-28DA03F8E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89557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5E106-B76B-4577-B4FA-59070E5BCED8}" type="datetimeFigureOut">
              <a:rPr lang="en-US" smtClean="0"/>
              <a:t>2023-06-0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0636-1D4A-4A18-B92A-28DA03F8E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40210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5E106-B76B-4577-B4FA-59070E5BCED8}" type="datetimeFigureOut">
              <a:rPr lang="en-US" smtClean="0"/>
              <a:t>2023-06-0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0636-1D4A-4A18-B92A-28DA03F8E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2949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D5E106-B76B-4577-B4FA-59070E5BCED8}" type="datetimeFigureOut">
              <a:rPr lang="en-US" smtClean="0"/>
              <a:t>2023-06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370636-1D4A-4A18-B92A-28DA03F8E5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737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1752" y="1490644"/>
            <a:ext cx="11740896" cy="193691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225296" y="3427561"/>
            <a:ext cx="502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FSC-A</a:t>
            </a:r>
          </a:p>
        </p:txBody>
      </p:sp>
      <p:sp>
        <p:nvSpPr>
          <p:cNvPr id="4" name="TextBox 3"/>
          <p:cNvSpPr txBox="1"/>
          <p:nvPr/>
        </p:nvSpPr>
        <p:spPr>
          <a:xfrm rot="16200000">
            <a:off x="-13716" y="2258567"/>
            <a:ext cx="5943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SSC-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495044" y="2830153"/>
            <a:ext cx="9189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Lymphocytes</a:t>
            </a:r>
          </a:p>
          <a:p>
            <a:pPr algn="ctr"/>
            <a:r>
              <a:rPr lang="en-US" sz="1000" dirty="0"/>
              <a:t>44.8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2378964" y="2255519"/>
            <a:ext cx="5943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FSC-H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293364" y="2168737"/>
            <a:ext cx="7848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Single cells</a:t>
            </a:r>
          </a:p>
          <a:p>
            <a:pPr algn="ctr"/>
            <a:r>
              <a:rPr lang="en-US" sz="1000" dirty="0"/>
              <a:t>98.6</a:t>
            </a:r>
          </a:p>
        </p:txBody>
      </p:sp>
      <p:sp>
        <p:nvSpPr>
          <p:cNvPr id="10" name="TextBox 9"/>
          <p:cNvSpPr txBox="1"/>
          <p:nvPr/>
        </p:nvSpPr>
        <p:spPr>
          <a:xfrm rot="16200000">
            <a:off x="4872228" y="2215895"/>
            <a:ext cx="5943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D3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335268" y="1978519"/>
            <a:ext cx="7848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D3</a:t>
            </a:r>
          </a:p>
          <a:p>
            <a:r>
              <a:rPr lang="en-US" sz="1000" dirty="0"/>
              <a:t>67.0</a:t>
            </a:r>
          </a:p>
        </p:txBody>
      </p:sp>
      <p:sp>
        <p:nvSpPr>
          <p:cNvPr id="12" name="TextBox 11"/>
          <p:cNvSpPr txBox="1"/>
          <p:nvPr/>
        </p:nvSpPr>
        <p:spPr>
          <a:xfrm rot="16200000">
            <a:off x="7319772" y="2212847"/>
            <a:ext cx="5943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D4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1027664" y="3427561"/>
            <a:ext cx="502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D38</a:t>
            </a:r>
          </a:p>
        </p:txBody>
      </p:sp>
      <p:cxnSp>
        <p:nvCxnSpPr>
          <p:cNvPr id="15" name="Straight Arrow Connector 14"/>
          <p:cNvCxnSpPr>
            <a:stCxn id="3" idx="3"/>
          </p:cNvCxnSpPr>
          <p:nvPr/>
        </p:nvCxnSpPr>
        <p:spPr>
          <a:xfrm>
            <a:off x="1728216" y="3550672"/>
            <a:ext cx="7708392" cy="15488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8720507" y="1847388"/>
            <a:ext cx="7848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D4</a:t>
            </a:r>
          </a:p>
          <a:p>
            <a:r>
              <a:rPr lang="en-US" sz="1000" dirty="0"/>
              <a:t>46.7</a:t>
            </a:r>
          </a:p>
        </p:txBody>
      </p:sp>
      <p:sp>
        <p:nvSpPr>
          <p:cNvPr id="18" name="TextBox 17"/>
          <p:cNvSpPr txBox="1"/>
          <p:nvPr/>
        </p:nvSpPr>
        <p:spPr>
          <a:xfrm rot="16200000">
            <a:off x="9747537" y="2280190"/>
            <a:ext cx="5943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HLA-DR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1658717" y="1564393"/>
            <a:ext cx="4269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.25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0871908" y="1572087"/>
            <a:ext cx="1170740" cy="106105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sz="700" dirty="0"/>
          </a:p>
        </p:txBody>
      </p:sp>
      <p:cxnSp>
        <p:nvCxnSpPr>
          <p:cNvPr id="22" name="Straight Arrow Connector 21"/>
          <p:cNvCxnSpPr/>
          <p:nvPr/>
        </p:nvCxnSpPr>
        <p:spPr>
          <a:xfrm>
            <a:off x="2414016" y="1636776"/>
            <a:ext cx="385239" cy="682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>
            <a:off x="4910278" y="1644494"/>
            <a:ext cx="385239" cy="682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>
            <a:off x="7331305" y="1657999"/>
            <a:ext cx="385239" cy="682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>
            <a:off x="9734970" y="1654141"/>
            <a:ext cx="385239" cy="682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260304" y="4416550"/>
            <a:ext cx="10383312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S1: Whole blood gating strategy. </a:t>
            </a:r>
          </a:p>
          <a:p>
            <a:r>
              <a:rPr lang="en-US" dirty="0"/>
              <a:t>Whole blood gating strategy for lymphocytes, single cells, CD3</a:t>
            </a:r>
            <a:r>
              <a:rPr lang="en-US" baseline="30000" dirty="0"/>
              <a:t>+</a:t>
            </a:r>
            <a:r>
              <a:rPr lang="en-US" dirty="0"/>
              <a:t> cells, CD4</a:t>
            </a:r>
            <a:r>
              <a:rPr lang="en-US" baseline="30000" dirty="0"/>
              <a:t>+ </a:t>
            </a:r>
            <a:r>
              <a:rPr lang="en-US" dirty="0"/>
              <a:t>T cells, and therein activated CD4</a:t>
            </a:r>
            <a:r>
              <a:rPr lang="en-US" baseline="30000" dirty="0"/>
              <a:t>+</a:t>
            </a:r>
            <a:r>
              <a:rPr lang="en-US" dirty="0"/>
              <a:t>HLA-DR</a:t>
            </a:r>
            <a:r>
              <a:rPr lang="en-US" baseline="30000" dirty="0"/>
              <a:t>+</a:t>
            </a:r>
            <a:r>
              <a:rPr lang="en-US" dirty="0"/>
              <a:t>CD38</a:t>
            </a:r>
            <a:r>
              <a:rPr lang="en-US" baseline="30000" dirty="0"/>
              <a:t>+ </a:t>
            </a:r>
            <a:r>
              <a:rPr lang="en-US" dirty="0"/>
              <a:t>T cells. The representative sample shows blood from 100 µL whole blood from a Tanzanian filarial lymphedema participant. Panel A: Forward scatter-height and side scatter-height were first used to gate the lymphocyte population. Panel B: Lymphocytes were then gated to find only single cells. Panel C: Single cells were then separated into CD3</a:t>
            </a:r>
            <a:r>
              <a:rPr lang="en-US" baseline="30000" dirty="0"/>
              <a:t>+</a:t>
            </a:r>
            <a:r>
              <a:rPr lang="en-US" dirty="0"/>
              <a:t> cells based on CD3 expression. Panel D: CD4</a:t>
            </a:r>
            <a:r>
              <a:rPr lang="en-US" baseline="30000" dirty="0"/>
              <a:t>+</a:t>
            </a:r>
            <a:r>
              <a:rPr lang="en-US" dirty="0"/>
              <a:t> T cells were then found using the CD4 expression. Panel E: Activated CD4</a:t>
            </a:r>
            <a:r>
              <a:rPr lang="en-US" baseline="30000" dirty="0"/>
              <a:t>+</a:t>
            </a:r>
            <a:r>
              <a:rPr lang="en-US" dirty="0"/>
              <a:t> T cells were found using the expression of HLADR and CD38 and defined as CD4</a:t>
            </a:r>
            <a:r>
              <a:rPr lang="en-US" baseline="30000" dirty="0"/>
              <a:t>+</a:t>
            </a:r>
            <a:r>
              <a:rPr lang="en-US" dirty="0"/>
              <a:t>HLA-DR</a:t>
            </a:r>
            <a:r>
              <a:rPr lang="en-US" baseline="30000" dirty="0"/>
              <a:t>+</a:t>
            </a:r>
            <a:r>
              <a:rPr lang="en-US" dirty="0"/>
              <a:t>CD38</a:t>
            </a:r>
            <a:r>
              <a:rPr lang="en-US" baseline="30000" dirty="0"/>
              <a:t>+</a:t>
            </a:r>
            <a:r>
              <a:rPr lang="en-US" dirty="0"/>
              <a:t>. The box in red indicates positive cell populations.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18539" y="1152090"/>
            <a:ext cx="4846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(A)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483787" y="1149042"/>
            <a:ext cx="4846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(B)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4976276" y="1147130"/>
            <a:ext cx="4846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(C)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7382784" y="1150677"/>
            <a:ext cx="4846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(D)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817642" y="1161312"/>
            <a:ext cx="4846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(E)</a:t>
            </a:r>
          </a:p>
        </p:txBody>
      </p:sp>
    </p:spTree>
    <p:extLst>
      <p:ext uri="{BB962C8B-B14F-4D97-AF65-F5344CB8AC3E}">
        <p14:creationId xmlns:p14="http://schemas.microsoft.com/office/powerpoint/2010/main" val="8105555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5868" y="2519147"/>
            <a:ext cx="8750965" cy="251244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0980" y="165740"/>
            <a:ext cx="8703630" cy="235340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875868" y="165740"/>
            <a:ext cx="4846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(A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749114" y="162692"/>
            <a:ext cx="4846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(B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637310" y="160780"/>
            <a:ext cx="4846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(C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964099" y="2652686"/>
            <a:ext cx="4846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(D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837345" y="2649638"/>
            <a:ext cx="4846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(E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725541" y="2647726"/>
            <a:ext cx="4846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(F)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70390" y="4786537"/>
            <a:ext cx="11424095" cy="214674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2: Counts of CD3</a:t>
            </a:r>
            <a:r>
              <a:rPr lang="en-US" sz="1400" b="1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D4</a:t>
            </a:r>
            <a:r>
              <a:rPr lang="en-US" sz="1400" b="1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CD8</a:t>
            </a:r>
            <a:r>
              <a:rPr lang="en-US" sz="1400" b="1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 cell populations among Ghanaian and Tanzanian lymphedema individuals. </a:t>
            </a:r>
            <a:endParaRPr lang="en-US" sz="1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 populations were analyzed according to the applied gating strategy (Supplementary Figure 1). Multiparametric flow cytometry analysis was used to measure the counts of CD3</a:t>
            </a:r>
            <a:r>
              <a:rPr lang="en-US" sz="13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A, D), CD4</a:t>
            </a:r>
            <a:r>
              <a:rPr lang="en-US" sz="13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B, E), and CD8</a:t>
            </a:r>
            <a:r>
              <a:rPr lang="en-US" sz="13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C, F) T cells from individuals displaying chronic leg lymphedema from </a:t>
            </a:r>
            <a:r>
              <a:rPr lang="en-US" sz="13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uchereria bancrofti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fection in Ghana and Tanzania. All individuals were classified according to the Dreyer lymphedema scale (Dreyer </a:t>
            </a:r>
            <a:r>
              <a:rPr lang="en-US" sz="13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t al </a:t>
            </a:r>
            <a:r>
              <a:rPr lang="en-US" sz="13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003) and classified as having low, medium, or advanced grade leg lymphedema. Kruskal-Wallis followed by Dunn’s multiple comparison post hoc analysis were used to find statistical significances between the groups (p&lt;0.05 statistically significant). </a:t>
            </a:r>
            <a:endParaRPr lang="en-US" sz="13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70390" y="109959"/>
            <a:ext cx="9850056" cy="222812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671332" y="1059084"/>
            <a:ext cx="7639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Ghana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70391" y="2558410"/>
            <a:ext cx="9850056" cy="222812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679121" y="3507535"/>
            <a:ext cx="9934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Tanzania</a:t>
            </a:r>
          </a:p>
        </p:txBody>
      </p:sp>
    </p:spTree>
    <p:extLst>
      <p:ext uri="{BB962C8B-B14F-4D97-AF65-F5344CB8AC3E}">
        <p14:creationId xmlns:p14="http://schemas.microsoft.com/office/powerpoint/2010/main" val="31658387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9</Words>
  <Application>Microsoft Office PowerPoint</Application>
  <PresentationFormat>Widescreen</PresentationFormat>
  <Paragraphs>3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cha Horn</dc:creator>
  <cp:lastModifiedBy>Zeljka Nikolic</cp:lastModifiedBy>
  <cp:revision>4</cp:revision>
  <dcterms:created xsi:type="dcterms:W3CDTF">2021-09-13T12:23:30Z</dcterms:created>
  <dcterms:modified xsi:type="dcterms:W3CDTF">2023-06-06T13:13:13Z</dcterms:modified>
</cp:coreProperties>
</file>